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62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sus-pc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6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62D2C-3700-4F30-B406-4BFFC5068201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51DF4-F034-4014-A8DD-019362572BF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827940" y="125041"/>
            <a:ext cx="6750951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1. 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ations number recorded and the relative abundance of each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ecies.</a:t>
            </a:r>
            <a:endParaRPr kumimoji="0" lang="en-US" altLang="zh-CN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/>
            </a:r>
            <a:b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kumimoji="0" lang="en-US" altLang="zh-CN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9" name="表格 8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056297" y="651582"/>
          <a:ext cx="6114174" cy="5669280"/>
        </p:xfrm>
        <a:graphic>
          <a:graphicData uri="http://schemas.openxmlformats.org/drawingml/2006/table">
            <a:tbl>
              <a:tblPr firstRow="1" firstCol="1" bandRow="1"/>
              <a:tblGrid>
                <a:gridCol w="1683668"/>
                <a:gridCol w="165102"/>
                <a:gridCol w="1524320"/>
                <a:gridCol w="878434"/>
                <a:gridCol w="1007352"/>
                <a:gridCol w="855298"/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ame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tation Numb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corded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verage RAI 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tandard Erro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quila </a:t>
                      </a:r>
                      <a:r>
                        <a:rPr lang="en-US" sz="600" i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hrysaetos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olden Eagl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148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0827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lliope pectoralis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hite-tailed </a:t>
                      </a:r>
                      <a:r>
                        <a:rPr lang="en-US" sz="6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ubythroat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090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0575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llosciurus erythrae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allas's Squirrel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6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79486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0.5130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pricornis sumatraensi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ainland Serow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15730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27229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rpodacus erythrin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ommon Rosefinc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5677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8170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hrysolophus amherstia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ady Amherst's Pheasan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569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399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oloeus dauuric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aurian Jackdaw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225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2948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olumba leuconot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now Pigeon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822209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1.5215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rossoptilon crossoptilon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hite Eared Pheasan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99631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689787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ryocopus marti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lack Woodpeck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56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3998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laphodus cephaloph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ufted de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17838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144233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mberiza godlewski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odlewski's Bunting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9066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6923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randala coelicolo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randal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454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2879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ystrix brachyur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alayan porcupin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990628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.608857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anthocincla maxim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iant Laughingthrus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5390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66699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thaginis cruent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lood Pheasan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97766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31977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epus com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unnan har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50894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07018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erwa lerw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now Partridg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181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1151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eucosticte brandt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randt's Mountain Finc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45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287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onchura punctulat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caly-breasted Muni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974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9449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ophophanes dichro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rey-crested Ti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347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4700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acaca mulatt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hesus Monkey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9721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52211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armota himalayan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malayan marmo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23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2352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artes flavigul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llow-throated marten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305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5935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oschus berezovski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est Musk De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3353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895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oschus chrysogast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lpine musk de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4484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10021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ustela sibiric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berian weasel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9044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4081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ycerobas carnipe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hite-winged Grosbeak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0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7200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aemorhedus caudat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ong-tailed Goral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80747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.214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ucifraga caryocatacte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potted Nutcracke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756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5325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arus mino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Japanese Ti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94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765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arus monticol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reen-backed Ti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679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2086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erdix hodgsonia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ibetan Partridg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0908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5757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hasianus colchic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ommon Pheasan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774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7200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hoenicurus aurore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aurian Redstar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2885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4460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hoenicurus frontali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lue-fronted Redstar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929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7400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hoenicurus schisticep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hite-throated Redstar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188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4704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ionailurus bengalensi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eopard ca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4713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78592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unella strophiat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ufous-breasted Accento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907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32462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seudois nayau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lue Sheep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0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.00927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.7616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crasia macroloph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oklass Pheasant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382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9445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yrrhocorax gracul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lpine Choug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3457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.49270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yrrhocorax pyrrhocorax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d-billed Chough 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3386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82840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hinopithecus biet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lack Snub-nosed Monkey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619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003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us scrof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ild boa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3603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3897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miops swinhoe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winhoe's Striped Squirrel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028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3369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rsiger chrysaeus 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olden Bush Robin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56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399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rsiger cyanur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range-flanked Bluetail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45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287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rsiger rufilat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malayan Bluetail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015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3480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etraogallus tibetan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ibetan Snowcock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0746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10444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etraophasis szechenyi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uff-throated Monal  Partridge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8494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08178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ochalopteron ellioti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lliot's Laughingthrus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1009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54268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upaia belanger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rthern Treeshrew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614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3385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urdus kessler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essler's Thrus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3321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7000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urdus mandarin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hinese Blackbird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636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17737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urdus rubrocan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hestnut Thrush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136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85475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rsus thibetanu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siatic black bear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6192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003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ulpes ferrilat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ibetan Fox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00693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6166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uhina gularis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tripe-throated Yuhina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05569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3998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 gridSpan="2">
                  <a:txBody>
                    <a:bodyPr/>
                    <a:lstStyle/>
                    <a:p>
                      <a:pPr algn="l"/>
                      <a:r>
                        <a:rPr lang="en-US" sz="6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Zoothera dixoni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12384</a:t>
                      </a:r>
                      <a:endParaRPr lang="zh-CN" sz="6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20066</a:t>
                      </a:r>
                      <a:endParaRPr lang="zh-CN" sz="6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4022" marR="240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图片 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070" y="0"/>
            <a:ext cx="7508875" cy="60051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-168790" y="6159574"/>
            <a:ext cx="944218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Figure 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S1.</a:t>
            </a:r>
            <a:r>
              <a:rPr kumimoji="0" lang="en-US" altLang="zh-CN" sz="16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 (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a</a:t>
            </a:r>
            <a:r>
              <a:rPr kumimoji="0" lang="en-US" altLang="zh-CN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) 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The relative abundance of mammals and ground birds against elevation in dry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season.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 </a:t>
            </a:r>
            <a:endParaRPr kumimoji="0" lang="en-US" altLang="zh-CN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charset="0"/>
              <a:ea typeface="等线" panose="02010600030101010101" pitchFamily="2" charset="-122"/>
              <a:cs typeface="Palatino Linotype" panose="0204050205050503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750" y="0"/>
            <a:ext cx="7265670" cy="581342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85629" y="5885180"/>
            <a:ext cx="914527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600" b="1" dirty="0">
                <a:ln>
                  <a:noFill/>
                </a:ln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  <a:sym typeface="+mn-ea"/>
              </a:rPr>
              <a:t>Figure </a:t>
            </a:r>
            <a:r>
              <a:rPr lang="en-US" altLang="zh-CN" sz="1600" b="1" dirty="0" smtClean="0">
                <a:ln>
                  <a:noFill/>
                </a:ln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  <a:sym typeface="+mn-ea"/>
              </a:rPr>
              <a:t>S1.</a:t>
            </a:r>
            <a:r>
              <a:rPr lang="en-US" altLang="zh-CN" sz="1600" b="1" kern="100" dirty="0" smtClean="0"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 </a:t>
            </a:r>
            <a:r>
              <a:rPr lang="en-US" altLang="zh-CN" sz="1600" kern="100" dirty="0" smtClean="0"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(</a:t>
            </a:r>
            <a:r>
              <a:rPr lang="en-US" altLang="zh-CN" sz="1600" b="1" kern="100" dirty="0" smtClean="0"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b</a:t>
            </a:r>
            <a:r>
              <a:rPr lang="en-US" altLang="zh-CN" sz="1600" kern="100" dirty="0" smtClean="0"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) </a:t>
            </a:r>
            <a:r>
              <a:rPr lang="en-US" altLang="zh-CN" sz="1600" kern="100" dirty="0"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The relative abundance of mammals and ground birds against elevation in rainy </a:t>
            </a:r>
            <a:r>
              <a:rPr lang="en-US" altLang="zh-CN" sz="1600" kern="100" dirty="0" smtClean="0">
                <a:effectLst/>
                <a:latin typeface="Palatino Linotype" panose="02040502050505030304" charset="0"/>
                <a:ea typeface="等线" panose="02010600030101010101" pitchFamily="2" charset="-122"/>
                <a:cs typeface="Palatino Linotype" panose="02040502050505030304" charset="0"/>
              </a:rPr>
              <a:t>season.</a:t>
            </a:r>
            <a:endParaRPr lang="en-US" altLang="zh-CN" sz="1600" kern="100" dirty="0">
              <a:effectLst/>
              <a:latin typeface="Palatino Linotype" panose="02040502050505030304" charset="0"/>
              <a:ea typeface="等线" panose="02010600030101010101" pitchFamily="2" charset="-122"/>
              <a:cs typeface="Palatino Linotype" panose="0204050205050503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430530" y="495300"/>
            <a:ext cx="7625080" cy="563689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1171575" y="5889625"/>
            <a:ext cx="7023519" cy="338554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sz="1600" b="1" dirty="0">
                <a:solidFill>
                  <a:srgbClr val="000000"/>
                </a:solidFill>
                <a:latin typeface="Palatino Linotype" panose="02040502050505030304" charset="0"/>
                <a:cs typeface="Times New Roman" panose="02020603050405020304" pitchFamily="18" charset="0"/>
              </a:rPr>
              <a:t>Figure S2. </a:t>
            </a:r>
            <a:r>
              <a:rPr lang="en-US" sz="1600" b="0" dirty="0">
                <a:solidFill>
                  <a:srgbClr val="000000"/>
                </a:solidFill>
                <a:latin typeface="Palatino Linotype" panose="02040502050505030304" charset="0"/>
                <a:cs typeface="Times New Roman" panose="02020603050405020304" pitchFamily="18" charset="0"/>
              </a:rPr>
              <a:t>The elevation distribution of blue sheep in different regions.</a:t>
            </a:r>
            <a:endParaRPr lang="en-US" altLang="en-US" sz="1600" b="0" dirty="0">
              <a:solidFill>
                <a:srgbClr val="000000"/>
              </a:solidFill>
              <a:latin typeface="Palatino Linotype" panose="0204050205050503030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8e9c3eb4-5570-4c4e-9b01-33e6e8bee39c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6165,&quot;width&quot;:8340}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02</Words>
  <Application>Microsoft Office PowerPoint</Application>
  <PresentationFormat>On-screen Show (4:3)</PresentationFormat>
  <Paragraphs>31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Palatino Linotype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DPI</cp:lastModifiedBy>
  <cp:revision>42</cp:revision>
  <dcterms:created xsi:type="dcterms:W3CDTF">2021-06-10T11:47:00Z</dcterms:created>
  <dcterms:modified xsi:type="dcterms:W3CDTF">2021-12-16T09:06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3972108923940619770B2E07CC38B5C</vt:lpwstr>
  </property>
  <property fmtid="{D5CDD505-2E9C-101B-9397-08002B2CF9AE}" pid="3" name="KSOProductBuildVer">
    <vt:lpwstr>2052-11.1.0.11115</vt:lpwstr>
  </property>
</Properties>
</file>